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65" d="100"/>
          <a:sy n="65" d="100"/>
        </p:scale>
        <p:origin x="-1482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\Desktop\Beacikk\MitoSox%20Analysis%20-%20Mitochondrial%20RO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\Desktop\Beacikk\MitoTracker%20Analysis%20-%20Mitochondrial%20potential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232228739727773"/>
          <c:y val="3.9657122102647949E-2"/>
          <c:w val="0.82463487008569025"/>
          <c:h val="0.45683887199969764"/>
        </c:manualLayout>
      </c:layout>
      <c:barChart>
        <c:barDir val="col"/>
        <c:grouping val="clustered"/>
        <c:varyColors val="0"/>
        <c:ser>
          <c:idx val="0"/>
          <c:order val="0"/>
          <c:tx>
            <c:v>0 min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ummary!$R$39:$R$43</c:f>
              <c:strCache>
                <c:ptCount val="5"/>
                <c:pt idx="0">
                  <c:v>DMSO</c:v>
                </c:pt>
                <c:pt idx="1">
                  <c:v>EtOH</c:v>
                </c:pt>
                <c:pt idx="2">
                  <c:v>Thapsigargin</c:v>
                </c:pt>
                <c:pt idx="3">
                  <c:v>CsA</c:v>
                </c:pt>
                <c:pt idx="4">
                  <c:v>Puromycin</c:v>
                </c:pt>
              </c:strCache>
            </c:strRef>
          </c:cat>
          <c:val>
            <c:numRef>
              <c:f>Summary!$S$39:$S$43</c:f>
              <c:numCache>
                <c:formatCode>General</c:formatCode>
                <c:ptCount val="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C70-4518-B90C-16E9AF7E509F}"/>
            </c:ext>
          </c:extLst>
        </c:ser>
        <c:ser>
          <c:idx val="1"/>
          <c:order val="1"/>
          <c:tx>
            <c:v>14 min</c:v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D$31:$D$35</c:f>
                <c:numCache>
                  <c:formatCode>General</c:formatCode>
                  <c:ptCount val="5"/>
                  <c:pt idx="0">
                    <c:v>0.15219082473079504</c:v>
                  </c:pt>
                  <c:pt idx="1">
                    <c:v>8.2265127593529552E-2</c:v>
                  </c:pt>
                  <c:pt idx="2">
                    <c:v>0.15338496989756462</c:v>
                  </c:pt>
                  <c:pt idx="3">
                    <c:v>0.2029817443525975</c:v>
                  </c:pt>
                  <c:pt idx="4">
                    <c:v>0.17327291685217192</c:v>
                  </c:pt>
                </c:numCache>
              </c:numRef>
            </c:plus>
            <c:minus>
              <c:numRef>
                <c:f>Summary!$D$31:$D$35</c:f>
                <c:numCache>
                  <c:formatCode>General</c:formatCode>
                  <c:ptCount val="5"/>
                  <c:pt idx="0">
                    <c:v>0.15219082473079504</c:v>
                  </c:pt>
                  <c:pt idx="1">
                    <c:v>8.2265127593529552E-2</c:v>
                  </c:pt>
                  <c:pt idx="2">
                    <c:v>0.15338496989756462</c:v>
                  </c:pt>
                  <c:pt idx="3">
                    <c:v>0.2029817443525975</c:v>
                  </c:pt>
                  <c:pt idx="4">
                    <c:v>0.1732729168521719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R$39:$R$43</c:f>
              <c:strCache>
                <c:ptCount val="5"/>
                <c:pt idx="0">
                  <c:v>DMSO</c:v>
                </c:pt>
                <c:pt idx="1">
                  <c:v>EtOH</c:v>
                </c:pt>
                <c:pt idx="2">
                  <c:v>Thapsigargin</c:v>
                </c:pt>
                <c:pt idx="3">
                  <c:v>CsA</c:v>
                </c:pt>
                <c:pt idx="4">
                  <c:v>Puromycin</c:v>
                </c:pt>
              </c:strCache>
            </c:strRef>
          </c:cat>
          <c:val>
            <c:numRef>
              <c:f>Summary!$T$39:$T$43</c:f>
              <c:numCache>
                <c:formatCode>General</c:formatCode>
                <c:ptCount val="5"/>
                <c:pt idx="0">
                  <c:v>1.1868333972770457</c:v>
                </c:pt>
                <c:pt idx="1">
                  <c:v>1.2965642087694216</c:v>
                </c:pt>
                <c:pt idx="2">
                  <c:v>1.2090987019854313</c:v>
                </c:pt>
                <c:pt idx="3">
                  <c:v>1.3609284888821309</c:v>
                </c:pt>
                <c:pt idx="4">
                  <c:v>1.258191295949864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FC70-4518-B90C-16E9AF7E509F}"/>
            </c:ext>
          </c:extLst>
        </c:ser>
        <c:ser>
          <c:idx val="2"/>
          <c:order val="2"/>
          <c:tx>
            <c:v>35 min</c:v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G$31:$G$35</c:f>
                <c:numCache>
                  <c:formatCode>General</c:formatCode>
                  <c:ptCount val="5"/>
                  <c:pt idx="0">
                    <c:v>0.34227403165507664</c:v>
                  </c:pt>
                  <c:pt idx="1">
                    <c:v>1.2419132754496331</c:v>
                  </c:pt>
                  <c:pt idx="2">
                    <c:v>0.35913786877201354</c:v>
                  </c:pt>
                  <c:pt idx="3">
                    <c:v>0.67607883113706957</c:v>
                  </c:pt>
                  <c:pt idx="4">
                    <c:v>0.49706664668282569</c:v>
                  </c:pt>
                </c:numCache>
              </c:numRef>
            </c:plus>
            <c:minus>
              <c:numRef>
                <c:f>Summary!$G$31:$G$35</c:f>
                <c:numCache>
                  <c:formatCode>General</c:formatCode>
                  <c:ptCount val="5"/>
                  <c:pt idx="0">
                    <c:v>0.34227403165507664</c:v>
                  </c:pt>
                  <c:pt idx="1">
                    <c:v>1.2419132754496331</c:v>
                  </c:pt>
                  <c:pt idx="2">
                    <c:v>0.35913786877201354</c:v>
                  </c:pt>
                  <c:pt idx="3">
                    <c:v>0.67607883113706957</c:v>
                  </c:pt>
                  <c:pt idx="4">
                    <c:v>0.4970666466828256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ummary!$U$39:$U$43</c:f>
              <c:numCache>
                <c:formatCode>General</c:formatCode>
                <c:ptCount val="5"/>
                <c:pt idx="0">
                  <c:v>1.3465032363949907</c:v>
                </c:pt>
                <c:pt idx="1">
                  <c:v>2.7609475947289783</c:v>
                </c:pt>
                <c:pt idx="2">
                  <c:v>1.3626820005400344</c:v>
                </c:pt>
                <c:pt idx="3">
                  <c:v>2.0622702751621893</c:v>
                </c:pt>
                <c:pt idx="4">
                  <c:v>1.610989269871074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FC70-4518-B90C-16E9AF7E50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1141760"/>
        <c:axId val="172032384"/>
      </c:barChart>
      <c:catAx>
        <c:axId val="1711417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0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72032384"/>
        <c:crosses val="autoZero"/>
        <c:auto val="1"/>
        <c:lblAlgn val="ctr"/>
        <c:lblOffset val="100"/>
        <c:noMultiLvlLbl val="0"/>
      </c:catAx>
      <c:valAx>
        <c:axId val="172032384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fold chang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31750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7114176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8723458004509506"/>
          <c:y val="2.1371517339216134E-2"/>
          <c:w val="0.52852107249287894"/>
          <c:h val="7.085221560275197E-2"/>
        </c:manualLayout>
      </c:layout>
      <c:overlay val="0"/>
      <c:spPr>
        <a:noFill/>
        <a:ln>
          <a:noFill/>
        </a:ln>
        <a:effectLst/>
      </c:spPr>
      <c:txPr>
        <a:bodyPr rot="0" vert="horz"/>
        <a:lstStyle/>
        <a:p>
          <a:pPr>
            <a:defRPr/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 b="1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ummary!$C$6</c:f>
              <c:strCache>
                <c:ptCount val="1"/>
                <c:pt idx="0">
                  <c:v>15 mi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D$10:$H$10</c:f>
                <c:numCache>
                  <c:formatCode>General</c:formatCode>
                  <c:ptCount val="5"/>
                  <c:pt idx="0">
                    <c:v>0.10517459971194619</c:v>
                  </c:pt>
                  <c:pt idx="1">
                    <c:v>0</c:v>
                  </c:pt>
                  <c:pt idx="2">
                    <c:v>0.13520408814944349</c:v>
                  </c:pt>
                  <c:pt idx="3">
                    <c:v>0.19688298962060491</c:v>
                  </c:pt>
                  <c:pt idx="4">
                    <c:v>0.21528795582572299</c:v>
                  </c:pt>
                </c:numCache>
              </c:numRef>
            </c:plus>
            <c:minus>
              <c:numRef>
                <c:f>Summary!$D$10:$H$10</c:f>
                <c:numCache>
                  <c:formatCode>General</c:formatCode>
                  <c:ptCount val="5"/>
                  <c:pt idx="0">
                    <c:v>0.10517459971194619</c:v>
                  </c:pt>
                  <c:pt idx="1">
                    <c:v>0</c:v>
                  </c:pt>
                  <c:pt idx="2">
                    <c:v>0.13520408814944349</c:v>
                  </c:pt>
                  <c:pt idx="3">
                    <c:v>0.19688298962060491</c:v>
                  </c:pt>
                  <c:pt idx="4">
                    <c:v>0.215287955825722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D$5:$H$5</c:f>
              <c:strCache>
                <c:ptCount val="5"/>
                <c:pt idx="0">
                  <c:v>Valinomycin</c:v>
                </c:pt>
                <c:pt idx="1">
                  <c:v>DMSO</c:v>
                </c:pt>
                <c:pt idx="2">
                  <c:v>Thapsigargin</c:v>
                </c:pt>
                <c:pt idx="3">
                  <c:v>CsA</c:v>
                </c:pt>
                <c:pt idx="4">
                  <c:v>Puromycin</c:v>
                </c:pt>
              </c:strCache>
            </c:strRef>
          </c:cat>
          <c:val>
            <c:numRef>
              <c:f>Summary!$D$6:$H$6</c:f>
              <c:numCache>
                <c:formatCode>0%</c:formatCode>
                <c:ptCount val="5"/>
                <c:pt idx="0">
                  <c:v>0.66603528959465197</c:v>
                </c:pt>
                <c:pt idx="1">
                  <c:v>1</c:v>
                </c:pt>
                <c:pt idx="2">
                  <c:v>1.0135809790083226</c:v>
                </c:pt>
                <c:pt idx="3">
                  <c:v>1.0218861694920052</c:v>
                </c:pt>
                <c:pt idx="4">
                  <c:v>0.9800720524539693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3C6-460A-A7B8-77755EB33E5F}"/>
            </c:ext>
          </c:extLst>
        </c:ser>
        <c:ser>
          <c:idx val="1"/>
          <c:order val="1"/>
          <c:tx>
            <c:strRef>
              <c:f>Summary!$C$7</c:f>
              <c:strCache>
                <c:ptCount val="1"/>
                <c:pt idx="0">
                  <c:v>30 mi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D$11:$H$11</c:f>
                <c:numCache>
                  <c:formatCode>General</c:formatCode>
                  <c:ptCount val="5"/>
                  <c:pt idx="0">
                    <c:v>6.769129591944352E-2</c:v>
                  </c:pt>
                  <c:pt idx="1">
                    <c:v>0.12383927280003564</c:v>
                  </c:pt>
                  <c:pt idx="2">
                    <c:v>0.21338084273522673</c:v>
                  </c:pt>
                  <c:pt idx="3">
                    <c:v>0.16694843297511297</c:v>
                  </c:pt>
                  <c:pt idx="4">
                    <c:v>0.14361744054030889</c:v>
                  </c:pt>
                </c:numCache>
              </c:numRef>
            </c:plus>
            <c:minus>
              <c:numRef>
                <c:f>Summary!$D$11:$H$11</c:f>
                <c:numCache>
                  <c:formatCode>General</c:formatCode>
                  <c:ptCount val="5"/>
                  <c:pt idx="0">
                    <c:v>6.769129591944352E-2</c:v>
                  </c:pt>
                  <c:pt idx="1">
                    <c:v>0.12383927280003564</c:v>
                  </c:pt>
                  <c:pt idx="2">
                    <c:v>0.21338084273522673</c:v>
                  </c:pt>
                  <c:pt idx="3">
                    <c:v>0.16694843297511297</c:v>
                  </c:pt>
                  <c:pt idx="4">
                    <c:v>0.1436174405403088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D$5:$H$5</c:f>
              <c:strCache>
                <c:ptCount val="5"/>
                <c:pt idx="0">
                  <c:v>Valinomycin</c:v>
                </c:pt>
                <c:pt idx="1">
                  <c:v>DMSO</c:v>
                </c:pt>
                <c:pt idx="2">
                  <c:v>Thapsigargin</c:v>
                </c:pt>
                <c:pt idx="3">
                  <c:v>CsA</c:v>
                </c:pt>
                <c:pt idx="4">
                  <c:v>Puromycin</c:v>
                </c:pt>
              </c:strCache>
            </c:strRef>
          </c:cat>
          <c:val>
            <c:numRef>
              <c:f>Summary!$D$7:$H$7</c:f>
              <c:numCache>
                <c:formatCode>0%</c:formatCode>
                <c:ptCount val="5"/>
                <c:pt idx="0">
                  <c:v>0.74971220682457818</c:v>
                </c:pt>
                <c:pt idx="1">
                  <c:v>1.0232978657479561</c:v>
                </c:pt>
                <c:pt idx="2">
                  <c:v>0.99686919902643589</c:v>
                </c:pt>
                <c:pt idx="3">
                  <c:v>0.9500856482133283</c:v>
                </c:pt>
                <c:pt idx="4">
                  <c:v>0.93076703997027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03C6-460A-A7B8-77755EB33E5F}"/>
            </c:ext>
          </c:extLst>
        </c:ser>
        <c:ser>
          <c:idx val="2"/>
          <c:order val="2"/>
          <c:tx>
            <c:strRef>
              <c:f>Summary!$C$8</c:f>
              <c:strCache>
                <c:ptCount val="1"/>
                <c:pt idx="0">
                  <c:v>60 min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D$12:$H$12</c:f>
                <c:numCache>
                  <c:formatCode>General</c:formatCode>
                  <c:ptCount val="5"/>
                  <c:pt idx="0">
                    <c:v>0.23412174498342339</c:v>
                  </c:pt>
                  <c:pt idx="1">
                    <c:v>0.18348561740303571</c:v>
                  </c:pt>
                  <c:pt idx="2">
                    <c:v>0.18028332169227848</c:v>
                  </c:pt>
                  <c:pt idx="3">
                    <c:v>0.15140555850008044</c:v>
                  </c:pt>
                  <c:pt idx="4">
                    <c:v>6.6631436396907121E-2</c:v>
                  </c:pt>
                </c:numCache>
              </c:numRef>
            </c:plus>
            <c:minus>
              <c:numRef>
                <c:f>Summary!$D$12:$H$12</c:f>
                <c:numCache>
                  <c:formatCode>General</c:formatCode>
                  <c:ptCount val="5"/>
                  <c:pt idx="0">
                    <c:v>0.23412174498342339</c:v>
                  </c:pt>
                  <c:pt idx="1">
                    <c:v>0.18348561740303571</c:v>
                  </c:pt>
                  <c:pt idx="2">
                    <c:v>0.18028332169227848</c:v>
                  </c:pt>
                  <c:pt idx="3">
                    <c:v>0.15140555850008044</c:v>
                  </c:pt>
                  <c:pt idx="4">
                    <c:v>6.663143639690712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D$5:$H$5</c:f>
              <c:strCache>
                <c:ptCount val="5"/>
                <c:pt idx="0">
                  <c:v>Valinomycin</c:v>
                </c:pt>
                <c:pt idx="1">
                  <c:v>DMSO</c:v>
                </c:pt>
                <c:pt idx="2">
                  <c:v>Thapsigargin</c:v>
                </c:pt>
                <c:pt idx="3">
                  <c:v>CsA</c:v>
                </c:pt>
                <c:pt idx="4">
                  <c:v>Puromycin</c:v>
                </c:pt>
              </c:strCache>
            </c:strRef>
          </c:cat>
          <c:val>
            <c:numRef>
              <c:f>Summary!$D$8:$H$8</c:f>
              <c:numCache>
                <c:formatCode>0%</c:formatCode>
                <c:ptCount val="5"/>
                <c:pt idx="0">
                  <c:v>0.76092596267887147</c:v>
                </c:pt>
                <c:pt idx="1">
                  <c:v>1.0227244288390223</c:v>
                </c:pt>
                <c:pt idx="2">
                  <c:v>0.93237029747525257</c:v>
                </c:pt>
                <c:pt idx="3">
                  <c:v>0.91467632878515825</c:v>
                </c:pt>
                <c:pt idx="4">
                  <c:v>0.8187060398301940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03C6-460A-A7B8-77755EB33E5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2511616"/>
        <c:axId val="172513152"/>
      </c:barChart>
      <c:catAx>
        <c:axId val="1725116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0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72513152"/>
        <c:crosses val="autoZero"/>
        <c:auto val="1"/>
        <c:lblAlgn val="ctr"/>
        <c:lblOffset val="100"/>
        <c:noMultiLvlLbl val="0"/>
      </c:catAx>
      <c:valAx>
        <c:axId val="172513152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 w="31750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7251161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4091904528557098"/>
          <c:y val="0"/>
          <c:w val="0.5944753087625253"/>
          <c:h val="0.10311067688116868"/>
        </c:manualLayout>
      </c:layout>
      <c:overlay val="0"/>
      <c:spPr>
        <a:noFill/>
        <a:ln>
          <a:noFill/>
        </a:ln>
        <a:effectLst/>
      </c:spPr>
      <c:txPr>
        <a:bodyPr rot="0" vert="horz"/>
        <a:lstStyle/>
        <a:p>
          <a:pPr>
            <a:defRPr/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 b="1"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4.8066177375342904E-2"/>
          <c:y val="3.9125401515269234E-2"/>
          <c:w val="0.74372842160119856"/>
          <c:h val="0.829581602775699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OCR!$AB$5</c:f>
              <c:strCache>
                <c:ptCount val="1"/>
                <c:pt idx="0">
                  <c:v>DMSO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OCR!$AC$31:$AC$35</c:f>
                <c:numCache>
                  <c:formatCode>General</c:formatCode>
                  <c:ptCount val="5"/>
                  <c:pt idx="0">
                    <c:v>6.9264975388844805</c:v>
                  </c:pt>
                  <c:pt idx="1">
                    <c:v>3.4130505720774327</c:v>
                  </c:pt>
                  <c:pt idx="2">
                    <c:v>13.03757683436076</c:v>
                  </c:pt>
                  <c:pt idx="3">
                    <c:v>9.6245262622833287</c:v>
                  </c:pt>
                  <c:pt idx="4">
                    <c:v>4.9129898150761928</c:v>
                  </c:pt>
                </c:numCache>
              </c:numRef>
            </c:plus>
            <c:minus>
              <c:numRef>
                <c:f>OCR!$AC$31:$AC$35</c:f>
                <c:numCache>
                  <c:formatCode>General</c:formatCode>
                  <c:ptCount val="5"/>
                  <c:pt idx="0">
                    <c:v>6.9264975388844805</c:v>
                  </c:pt>
                  <c:pt idx="1">
                    <c:v>3.4130505720774327</c:v>
                  </c:pt>
                  <c:pt idx="2">
                    <c:v>13.03757683436076</c:v>
                  </c:pt>
                  <c:pt idx="3">
                    <c:v>9.6245262622833287</c:v>
                  </c:pt>
                  <c:pt idx="4">
                    <c:v>4.9129898150761928</c:v>
                  </c:pt>
                </c:numCache>
              </c:numRef>
            </c:minus>
          </c:errBars>
          <c:cat>
            <c:strRef>
              <c:f>OCR!$Z$31:$Z$35</c:f>
              <c:strCache>
                <c:ptCount val="5"/>
                <c:pt idx="0">
                  <c:v>Basal Respiration</c:v>
                </c:pt>
                <c:pt idx="1">
                  <c:v>ATP production</c:v>
                </c:pt>
                <c:pt idx="2">
                  <c:v>Maximal Respiration</c:v>
                </c:pt>
                <c:pt idx="3">
                  <c:v>Spare Capacity</c:v>
                </c:pt>
                <c:pt idx="4">
                  <c:v>Non-Mito</c:v>
                </c:pt>
              </c:strCache>
            </c:strRef>
          </c:cat>
          <c:val>
            <c:numRef>
              <c:f>OCR!$AB$31:$AB$35</c:f>
              <c:numCache>
                <c:formatCode>0.000</c:formatCode>
                <c:ptCount val="5"/>
                <c:pt idx="0">
                  <c:v>35.05057843526204</c:v>
                </c:pt>
                <c:pt idx="1">
                  <c:v>5.712954203287758</c:v>
                </c:pt>
                <c:pt idx="2">
                  <c:v>31.990085601806641</c:v>
                </c:pt>
                <c:pt idx="3">
                  <c:v>26.277131398518883</c:v>
                </c:pt>
                <c:pt idx="4">
                  <c:v>26.27643013000488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1C2-48E3-A092-F63083230B06}"/>
            </c:ext>
          </c:extLst>
        </c:ser>
        <c:ser>
          <c:idx val="1"/>
          <c:order val="1"/>
          <c:tx>
            <c:strRef>
              <c:f>OCR!$AD$5</c:f>
              <c:strCache>
                <c:ptCount val="1"/>
                <c:pt idx="0">
                  <c:v>Puromycin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OCR!$AE$31:$AE$35</c:f>
                <c:numCache>
                  <c:formatCode>General</c:formatCode>
                  <c:ptCount val="5"/>
                  <c:pt idx="0">
                    <c:v>5.9108766317367554</c:v>
                  </c:pt>
                  <c:pt idx="1">
                    <c:v>2.5949346224466963</c:v>
                  </c:pt>
                  <c:pt idx="2">
                    <c:v>11.207800348599751</c:v>
                  </c:pt>
                  <c:pt idx="3">
                    <c:v>8.6128657261530552</c:v>
                  </c:pt>
                  <c:pt idx="4">
                    <c:v>5.506153504053751</c:v>
                  </c:pt>
                </c:numCache>
              </c:numRef>
            </c:plus>
            <c:minus>
              <c:numRef>
                <c:f>OCR!$AE$31:$AE$35</c:f>
                <c:numCache>
                  <c:formatCode>General</c:formatCode>
                  <c:ptCount val="5"/>
                  <c:pt idx="0">
                    <c:v>5.9108766317367554</c:v>
                  </c:pt>
                  <c:pt idx="1">
                    <c:v>2.5949346224466963</c:v>
                  </c:pt>
                  <c:pt idx="2">
                    <c:v>11.207800348599751</c:v>
                  </c:pt>
                  <c:pt idx="3">
                    <c:v>8.6128657261530552</c:v>
                  </c:pt>
                  <c:pt idx="4">
                    <c:v>5.506153504053751</c:v>
                  </c:pt>
                </c:numCache>
              </c:numRef>
            </c:minus>
          </c:errBars>
          <c:cat>
            <c:strRef>
              <c:f>OCR!$Z$31:$Z$35</c:f>
              <c:strCache>
                <c:ptCount val="5"/>
                <c:pt idx="0">
                  <c:v>Basal Respiration</c:v>
                </c:pt>
                <c:pt idx="1">
                  <c:v>ATP production</c:v>
                </c:pt>
                <c:pt idx="2">
                  <c:v>Maximal Respiration</c:v>
                </c:pt>
                <c:pt idx="3">
                  <c:v>Spare Capacity</c:v>
                </c:pt>
                <c:pt idx="4">
                  <c:v>Non-Mito</c:v>
                </c:pt>
              </c:strCache>
            </c:strRef>
          </c:cat>
          <c:val>
            <c:numRef>
              <c:f>OCR!$AD$31:$AD$35</c:f>
              <c:numCache>
                <c:formatCode>0.000</c:formatCode>
                <c:ptCount val="5"/>
                <c:pt idx="0">
                  <c:v>36.88255373636882</c:v>
                </c:pt>
                <c:pt idx="1">
                  <c:v>7.548377354939781</c:v>
                </c:pt>
                <c:pt idx="2">
                  <c:v>46.903598785400398</c:v>
                </c:pt>
                <c:pt idx="3">
                  <c:v>39.355221430460617</c:v>
                </c:pt>
                <c:pt idx="4">
                  <c:v>33.02707862854003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01C2-48E3-A092-F63083230B06}"/>
            </c:ext>
          </c:extLst>
        </c:ser>
        <c:ser>
          <c:idx val="2"/>
          <c:order val="2"/>
          <c:tx>
            <c:strRef>
              <c:f>OCR!$AF$5</c:f>
              <c:strCache>
                <c:ptCount val="1"/>
                <c:pt idx="0">
                  <c:v>CsA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OCR!$AG$31:$AG$35</c:f>
                <c:numCache>
                  <c:formatCode>General</c:formatCode>
                  <c:ptCount val="5"/>
                  <c:pt idx="0">
                    <c:v>9.5089980761210136</c:v>
                  </c:pt>
                  <c:pt idx="1">
                    <c:v>0.31639409065246582</c:v>
                  </c:pt>
                  <c:pt idx="2">
                    <c:v>5.9247791767120344</c:v>
                  </c:pt>
                  <c:pt idx="3">
                    <c:v>5.6083850860595685</c:v>
                  </c:pt>
                  <c:pt idx="4">
                    <c:v>4.8205877145131435</c:v>
                  </c:pt>
                </c:numCache>
              </c:numRef>
            </c:plus>
            <c:minus>
              <c:numRef>
                <c:f>OCR!$AG$31:$AG$35</c:f>
                <c:numCache>
                  <c:formatCode>General</c:formatCode>
                  <c:ptCount val="5"/>
                  <c:pt idx="0">
                    <c:v>9.5089980761210136</c:v>
                  </c:pt>
                  <c:pt idx="1">
                    <c:v>0.31639409065246582</c:v>
                  </c:pt>
                  <c:pt idx="2">
                    <c:v>5.9247791767120344</c:v>
                  </c:pt>
                  <c:pt idx="3">
                    <c:v>5.6083850860595685</c:v>
                  </c:pt>
                  <c:pt idx="4">
                    <c:v>4.8205877145131435</c:v>
                  </c:pt>
                </c:numCache>
              </c:numRef>
            </c:minus>
          </c:errBars>
          <c:cat>
            <c:strRef>
              <c:f>OCR!$Z$31:$Z$35</c:f>
              <c:strCache>
                <c:ptCount val="5"/>
                <c:pt idx="0">
                  <c:v>Basal Respiration</c:v>
                </c:pt>
                <c:pt idx="1">
                  <c:v>ATP production</c:v>
                </c:pt>
                <c:pt idx="2">
                  <c:v>Maximal Respiration</c:v>
                </c:pt>
                <c:pt idx="3">
                  <c:v>Spare Capacity</c:v>
                </c:pt>
                <c:pt idx="4">
                  <c:v>Non-Mito</c:v>
                </c:pt>
              </c:strCache>
            </c:strRef>
          </c:cat>
          <c:val>
            <c:numRef>
              <c:f>OCR!$AF$31:$AF$35</c:f>
              <c:numCache>
                <c:formatCode>0.000</c:formatCode>
                <c:ptCount val="5"/>
                <c:pt idx="0">
                  <c:v>47.756735483805343</c:v>
                </c:pt>
                <c:pt idx="1">
                  <c:v>5.7316538492838589</c:v>
                </c:pt>
                <c:pt idx="2">
                  <c:v>27.180427551269531</c:v>
                </c:pt>
                <c:pt idx="3">
                  <c:v>21.448773701985672</c:v>
                </c:pt>
                <c:pt idx="4">
                  <c:v>27.09579976399739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01C2-48E3-A092-F63083230B06}"/>
            </c:ext>
          </c:extLst>
        </c:ser>
        <c:ser>
          <c:idx val="3"/>
          <c:order val="3"/>
          <c:tx>
            <c:strRef>
              <c:f>OCR!$AH$5</c:f>
              <c:strCache>
                <c:ptCount val="1"/>
                <c:pt idx="0">
                  <c:v>Thapsigargin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OCR!$AI$31:$AI$35</c:f>
                <c:numCache>
                  <c:formatCode>General</c:formatCode>
                  <c:ptCount val="5"/>
                  <c:pt idx="0">
                    <c:v>9.9228358268737793</c:v>
                  </c:pt>
                  <c:pt idx="1">
                    <c:v>2.6077583630879726</c:v>
                  </c:pt>
                  <c:pt idx="2">
                    <c:v>9.4753098487853986</c:v>
                  </c:pt>
                  <c:pt idx="3">
                    <c:v>6.867551485697426</c:v>
                  </c:pt>
                  <c:pt idx="4">
                    <c:v>4.8423678874969482</c:v>
                  </c:pt>
                </c:numCache>
              </c:numRef>
            </c:plus>
            <c:minus>
              <c:numRef>
                <c:f>OCR!$AI$31:$AI$35</c:f>
                <c:numCache>
                  <c:formatCode>General</c:formatCode>
                  <c:ptCount val="5"/>
                  <c:pt idx="0">
                    <c:v>9.9228358268737793</c:v>
                  </c:pt>
                  <c:pt idx="1">
                    <c:v>2.6077583630879726</c:v>
                  </c:pt>
                  <c:pt idx="2">
                    <c:v>9.4753098487853986</c:v>
                  </c:pt>
                  <c:pt idx="3">
                    <c:v>6.867551485697426</c:v>
                  </c:pt>
                  <c:pt idx="4">
                    <c:v>4.8423678874969482</c:v>
                  </c:pt>
                </c:numCache>
              </c:numRef>
            </c:minus>
          </c:errBars>
          <c:cat>
            <c:strRef>
              <c:f>OCR!$Z$31:$Z$35</c:f>
              <c:strCache>
                <c:ptCount val="5"/>
                <c:pt idx="0">
                  <c:v>Basal Respiration</c:v>
                </c:pt>
                <c:pt idx="1">
                  <c:v>ATP production</c:v>
                </c:pt>
                <c:pt idx="2">
                  <c:v>Maximal Respiration</c:v>
                </c:pt>
                <c:pt idx="3">
                  <c:v>Spare Capacity</c:v>
                </c:pt>
                <c:pt idx="4">
                  <c:v>Non-Mito</c:v>
                </c:pt>
              </c:strCache>
            </c:strRef>
          </c:cat>
          <c:val>
            <c:numRef>
              <c:f>OCR!$AH$31:$AH$35</c:f>
              <c:numCache>
                <c:formatCode>0.000</c:formatCode>
                <c:ptCount val="5"/>
                <c:pt idx="0">
                  <c:v>39.916529973347977</c:v>
                </c:pt>
                <c:pt idx="1">
                  <c:v>11.805754979451493</c:v>
                </c:pt>
                <c:pt idx="2">
                  <c:v>38.05494499206543</c:v>
                </c:pt>
                <c:pt idx="3">
                  <c:v>26.249190012613937</c:v>
                </c:pt>
                <c:pt idx="4">
                  <c:v>13.8171811103820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01C2-48E3-A092-F63083230B0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8509696"/>
        <c:axId val="178511232"/>
      </c:barChart>
      <c:catAx>
        <c:axId val="17850969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31750">
            <a:solidFill>
              <a:schemeClr val="tx1"/>
            </a:solidFill>
          </a:ln>
        </c:spPr>
        <c:txPr>
          <a:bodyPr/>
          <a:lstStyle/>
          <a:p>
            <a:pPr>
              <a:defRPr sz="1000" b="1"/>
            </a:pPr>
            <a:endParaRPr lang="en-US"/>
          </a:p>
        </c:txPr>
        <c:crossAx val="178511232"/>
        <c:crosses val="autoZero"/>
        <c:auto val="1"/>
        <c:lblAlgn val="ctr"/>
        <c:lblOffset val="100"/>
        <c:noMultiLvlLbl val="0"/>
      </c:catAx>
      <c:valAx>
        <c:axId val="178511232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0" sourceLinked="0"/>
        <c:majorTickMark val="out"/>
        <c:minorTickMark val="none"/>
        <c:tickLblPos val="nextTo"/>
        <c:spPr>
          <a:ln w="31750">
            <a:solidFill>
              <a:schemeClr val="tx1"/>
            </a:solidFill>
          </a:ln>
        </c:spPr>
        <c:txPr>
          <a:bodyPr/>
          <a:lstStyle/>
          <a:p>
            <a:pPr>
              <a:defRPr sz="1400"/>
            </a:pPr>
            <a:endParaRPr lang="en-US"/>
          </a:p>
        </c:txPr>
        <c:crossAx val="178509696"/>
        <c:crosses val="autoZero"/>
        <c:crossBetween val="between"/>
      </c:valAx>
    </c:plotArea>
    <c:legend>
      <c:legendPos val="tr"/>
      <c:layout>
        <c:manualLayout>
          <c:xMode val="edge"/>
          <c:yMode val="edge"/>
          <c:x val="0.1158327361052222"/>
          <c:y val="3.7084915404051832E-3"/>
          <c:w val="0.73458282209356285"/>
          <c:h val="9.9394873463056546E-2"/>
        </c:manualLayout>
      </c:layout>
      <c:overlay val="0"/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tx>
            <c:strRef>
              <c:f>OCR!$AB$5</c:f>
              <c:strCache>
                <c:ptCount val="1"/>
                <c:pt idx="0">
                  <c:v>DMSO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OCR!$AC$13:$AC$29</c:f>
                <c:numCache>
                  <c:formatCode>General</c:formatCode>
                  <c:ptCount val="17"/>
                  <c:pt idx="0">
                    <c:v>5.2942200501759853</c:v>
                  </c:pt>
                  <c:pt idx="1">
                    <c:v>6.2878692150115967</c:v>
                  </c:pt>
                  <c:pt idx="2">
                    <c:v>6.705418586730957</c:v>
                  </c:pt>
                  <c:pt idx="3">
                    <c:v>6.8089630603790283</c:v>
                  </c:pt>
                  <c:pt idx="4">
                    <c:v>6.9264975388844805</c:v>
                  </c:pt>
                  <c:pt idx="5">
                    <c:v>4.94094435373942</c:v>
                  </c:pt>
                  <c:pt idx="6">
                    <c:v>4.1643067995707188</c:v>
                  </c:pt>
                  <c:pt idx="7">
                    <c:v>3.7921073436737061</c:v>
                  </c:pt>
                  <c:pt idx="8">
                    <c:v>3.5134469668070478</c:v>
                  </c:pt>
                  <c:pt idx="9">
                    <c:v>16.789960861206055</c:v>
                  </c:pt>
                  <c:pt idx="10">
                    <c:v>16.130685806274414</c:v>
                  </c:pt>
                  <c:pt idx="11">
                    <c:v>16.355822563171387</c:v>
                  </c:pt>
                  <c:pt idx="12">
                    <c:v>16.551023801167808</c:v>
                  </c:pt>
                  <c:pt idx="13">
                    <c:v>6.3450693289438886</c:v>
                  </c:pt>
                  <c:pt idx="14">
                    <c:v>6.0324831008911133</c:v>
                  </c:pt>
                  <c:pt idx="15">
                    <c:v>5.7458769480387364</c:v>
                  </c:pt>
                  <c:pt idx="16">
                    <c:v>4.9129898150761928</c:v>
                  </c:pt>
                </c:numCache>
              </c:numRef>
            </c:plus>
            <c:minus>
              <c:numRef>
                <c:f>OCR!$AC$13:$AC$29</c:f>
                <c:numCache>
                  <c:formatCode>General</c:formatCode>
                  <c:ptCount val="17"/>
                  <c:pt idx="0">
                    <c:v>5.2942200501759853</c:v>
                  </c:pt>
                  <c:pt idx="1">
                    <c:v>6.2878692150115967</c:v>
                  </c:pt>
                  <c:pt idx="2">
                    <c:v>6.705418586730957</c:v>
                  </c:pt>
                  <c:pt idx="3">
                    <c:v>6.8089630603790283</c:v>
                  </c:pt>
                  <c:pt idx="4">
                    <c:v>6.9264975388844805</c:v>
                  </c:pt>
                  <c:pt idx="5">
                    <c:v>4.94094435373942</c:v>
                  </c:pt>
                  <c:pt idx="6">
                    <c:v>4.1643067995707188</c:v>
                  </c:pt>
                  <c:pt idx="7">
                    <c:v>3.7921073436737061</c:v>
                  </c:pt>
                  <c:pt idx="8">
                    <c:v>3.5134469668070478</c:v>
                  </c:pt>
                  <c:pt idx="9">
                    <c:v>16.789960861206055</c:v>
                  </c:pt>
                  <c:pt idx="10">
                    <c:v>16.130685806274414</c:v>
                  </c:pt>
                  <c:pt idx="11">
                    <c:v>16.355822563171387</c:v>
                  </c:pt>
                  <c:pt idx="12">
                    <c:v>16.551023801167808</c:v>
                  </c:pt>
                  <c:pt idx="13">
                    <c:v>6.3450693289438886</c:v>
                  </c:pt>
                  <c:pt idx="14">
                    <c:v>6.0324831008911133</c:v>
                  </c:pt>
                  <c:pt idx="15">
                    <c:v>5.7458769480387364</c:v>
                  </c:pt>
                  <c:pt idx="16">
                    <c:v>4.9129898150761928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OCR!$AK$13:$AK$29</c:f>
              <c:numCache>
                <c:formatCode>0</c:formatCode>
                <c:ptCount val="17"/>
                <c:pt idx="0">
                  <c:v>0.33333206176757813</c:v>
                </c:pt>
                <c:pt idx="1">
                  <c:v>6.0833320617675781</c:v>
                </c:pt>
                <c:pt idx="2">
                  <c:v>11.833332061767578</c:v>
                </c:pt>
                <c:pt idx="3">
                  <c:v>17.583332061767578</c:v>
                </c:pt>
                <c:pt idx="4">
                  <c:v>23.333332061767578</c:v>
                </c:pt>
                <c:pt idx="5">
                  <c:v>29.316665649414062</c:v>
                </c:pt>
                <c:pt idx="6">
                  <c:v>35.066665649414063</c:v>
                </c:pt>
                <c:pt idx="7">
                  <c:v>40.833335876464844</c:v>
                </c:pt>
                <c:pt idx="8">
                  <c:v>46.583335876464844</c:v>
                </c:pt>
                <c:pt idx="9">
                  <c:v>52.566665649414063</c:v>
                </c:pt>
                <c:pt idx="10">
                  <c:v>58.316665649414063</c:v>
                </c:pt>
                <c:pt idx="11">
                  <c:v>64.066665649414063</c:v>
                </c:pt>
                <c:pt idx="12">
                  <c:v>69.816665649414063</c:v>
                </c:pt>
                <c:pt idx="13">
                  <c:v>75.816665649414063</c:v>
                </c:pt>
                <c:pt idx="14">
                  <c:v>81.566665649414063</c:v>
                </c:pt>
                <c:pt idx="15">
                  <c:v>87.316665649414063</c:v>
                </c:pt>
                <c:pt idx="16">
                  <c:v>93.066665649414063</c:v>
                </c:pt>
              </c:numCache>
            </c:numRef>
          </c:xVal>
          <c:yVal>
            <c:numRef>
              <c:f>OCR!$AB$13:$AB$29</c:f>
              <c:numCache>
                <c:formatCode>0.000</c:formatCode>
                <c:ptCount val="17"/>
                <c:pt idx="0">
                  <c:v>31.21104907989502</c:v>
                </c:pt>
                <c:pt idx="1">
                  <c:v>33.866263071695968</c:v>
                </c:pt>
                <c:pt idx="2">
                  <c:v>34.971504211425781</c:v>
                </c:pt>
                <c:pt idx="3">
                  <c:v>35.837073644002274</c:v>
                </c:pt>
                <c:pt idx="4">
                  <c:v>35.05057843526204</c:v>
                </c:pt>
                <c:pt idx="5">
                  <c:v>29.686232884724937</c:v>
                </c:pt>
                <c:pt idx="6">
                  <c:v>29.286103566487633</c:v>
                </c:pt>
                <c:pt idx="7">
                  <c:v>30.20556958516439</c:v>
                </c:pt>
                <c:pt idx="8">
                  <c:v>29.337624231974281</c:v>
                </c:pt>
                <c:pt idx="9">
                  <c:v>61.1727294921875</c:v>
                </c:pt>
                <c:pt idx="10">
                  <c:v>61.894973754882813</c:v>
                </c:pt>
                <c:pt idx="11">
                  <c:v>62.527849197387695</c:v>
                </c:pt>
                <c:pt idx="12">
                  <c:v>61.327709833780922</c:v>
                </c:pt>
                <c:pt idx="13">
                  <c:v>35.040990193684891</c:v>
                </c:pt>
                <c:pt idx="14">
                  <c:v>35.207284291585282</c:v>
                </c:pt>
                <c:pt idx="15">
                  <c:v>33.258296966552734</c:v>
                </c:pt>
                <c:pt idx="16">
                  <c:v>26.276430130004883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F1DD-4F89-978B-6EB4230BE8C1}"/>
            </c:ext>
          </c:extLst>
        </c:ser>
        <c:ser>
          <c:idx val="1"/>
          <c:order val="1"/>
          <c:tx>
            <c:strRef>
              <c:f>OCR!$AD$5</c:f>
              <c:strCache>
                <c:ptCount val="1"/>
                <c:pt idx="0">
                  <c:v>Puromycin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OCR!$AE$13:$AE$29</c:f>
                <c:numCache>
                  <c:formatCode>General</c:formatCode>
                  <c:ptCount val="17"/>
                  <c:pt idx="0">
                    <c:v>4.3081406752268467</c:v>
                  </c:pt>
                  <c:pt idx="1">
                    <c:v>5.2631214459737148</c:v>
                  </c:pt>
                  <c:pt idx="2">
                    <c:v>5.7132766246795654</c:v>
                  </c:pt>
                  <c:pt idx="3">
                    <c:v>5.7449096043904628</c:v>
                  </c:pt>
                  <c:pt idx="4">
                    <c:v>5.9108766317367554</c:v>
                  </c:pt>
                  <c:pt idx="5">
                    <c:v>4.2985445261001587</c:v>
                  </c:pt>
                  <c:pt idx="6">
                    <c:v>3.6987212498982749</c:v>
                  </c:pt>
                  <c:pt idx="7">
                    <c:v>3.4836018482844038</c:v>
                  </c:pt>
                  <c:pt idx="8">
                    <c:v>3.3159420092900591</c:v>
                  </c:pt>
                  <c:pt idx="9">
                    <c:v>15.085115432739258</c:v>
                  </c:pt>
                  <c:pt idx="10">
                    <c:v>14.930253823598227</c:v>
                  </c:pt>
                  <c:pt idx="11">
                    <c:v>14.627092520395914</c:v>
                  </c:pt>
                  <c:pt idx="12">
                    <c:v>14.523742357889811</c:v>
                  </c:pt>
                  <c:pt idx="13">
                    <c:v>6.9692457516988124</c:v>
                  </c:pt>
                  <c:pt idx="14">
                    <c:v>6.1833748817443848</c:v>
                  </c:pt>
                  <c:pt idx="15">
                    <c:v>5.9787569046020508</c:v>
                  </c:pt>
                  <c:pt idx="16">
                    <c:v>5.506153504053751</c:v>
                  </c:pt>
                </c:numCache>
              </c:numRef>
            </c:plus>
            <c:minus>
              <c:numRef>
                <c:f>OCR!$AE$13:$AE$29</c:f>
                <c:numCache>
                  <c:formatCode>General</c:formatCode>
                  <c:ptCount val="17"/>
                  <c:pt idx="0">
                    <c:v>4.3081406752268467</c:v>
                  </c:pt>
                  <c:pt idx="1">
                    <c:v>5.2631214459737148</c:v>
                  </c:pt>
                  <c:pt idx="2">
                    <c:v>5.7132766246795654</c:v>
                  </c:pt>
                  <c:pt idx="3">
                    <c:v>5.7449096043904628</c:v>
                  </c:pt>
                  <c:pt idx="4">
                    <c:v>5.9108766317367554</c:v>
                  </c:pt>
                  <c:pt idx="5">
                    <c:v>4.2985445261001587</c:v>
                  </c:pt>
                  <c:pt idx="6">
                    <c:v>3.6987212498982749</c:v>
                  </c:pt>
                  <c:pt idx="7">
                    <c:v>3.4836018482844038</c:v>
                  </c:pt>
                  <c:pt idx="8">
                    <c:v>3.3159420092900591</c:v>
                  </c:pt>
                  <c:pt idx="9">
                    <c:v>15.085115432739258</c:v>
                  </c:pt>
                  <c:pt idx="10">
                    <c:v>14.930253823598227</c:v>
                  </c:pt>
                  <c:pt idx="11">
                    <c:v>14.627092520395914</c:v>
                  </c:pt>
                  <c:pt idx="12">
                    <c:v>14.523742357889811</c:v>
                  </c:pt>
                  <c:pt idx="13">
                    <c:v>6.9692457516988124</c:v>
                  </c:pt>
                  <c:pt idx="14">
                    <c:v>6.1833748817443848</c:v>
                  </c:pt>
                  <c:pt idx="15">
                    <c:v>5.9787569046020508</c:v>
                  </c:pt>
                  <c:pt idx="16">
                    <c:v>5.506153504053751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OCR!$AK$13:$AK$29</c:f>
              <c:numCache>
                <c:formatCode>0</c:formatCode>
                <c:ptCount val="17"/>
                <c:pt idx="0">
                  <c:v>0.33333206176757813</c:v>
                </c:pt>
                <c:pt idx="1">
                  <c:v>6.0833320617675781</c:v>
                </c:pt>
                <c:pt idx="2">
                  <c:v>11.833332061767578</c:v>
                </c:pt>
                <c:pt idx="3">
                  <c:v>17.583332061767578</c:v>
                </c:pt>
                <c:pt idx="4">
                  <c:v>23.333332061767578</c:v>
                </c:pt>
                <c:pt idx="5">
                  <c:v>29.316665649414062</c:v>
                </c:pt>
                <c:pt idx="6">
                  <c:v>35.066665649414063</c:v>
                </c:pt>
                <c:pt idx="7">
                  <c:v>40.833335876464844</c:v>
                </c:pt>
                <c:pt idx="8">
                  <c:v>46.583335876464844</c:v>
                </c:pt>
                <c:pt idx="9">
                  <c:v>52.566665649414063</c:v>
                </c:pt>
                <c:pt idx="10">
                  <c:v>58.316665649414063</c:v>
                </c:pt>
                <c:pt idx="11">
                  <c:v>64.066665649414063</c:v>
                </c:pt>
                <c:pt idx="12">
                  <c:v>69.816665649414063</c:v>
                </c:pt>
                <c:pt idx="13">
                  <c:v>75.816665649414063</c:v>
                </c:pt>
                <c:pt idx="14">
                  <c:v>81.566665649414063</c:v>
                </c:pt>
                <c:pt idx="15">
                  <c:v>87.316665649414063</c:v>
                </c:pt>
                <c:pt idx="16">
                  <c:v>93.066665649414063</c:v>
                </c:pt>
              </c:numCache>
            </c:numRef>
          </c:xVal>
          <c:yVal>
            <c:numRef>
              <c:f>OCR!$AD$13:$AD$29</c:f>
              <c:numCache>
                <c:formatCode>0.000</c:formatCode>
                <c:ptCount val="17"/>
                <c:pt idx="0">
                  <c:v>34.59184455871582</c:v>
                </c:pt>
                <c:pt idx="1">
                  <c:v>37.753685633341476</c:v>
                </c:pt>
                <c:pt idx="2">
                  <c:v>37.269643783569336</c:v>
                </c:pt>
                <c:pt idx="3">
                  <c:v>38.32491811116536</c:v>
                </c:pt>
                <c:pt idx="4">
                  <c:v>36.88255373636882</c:v>
                </c:pt>
                <c:pt idx="5">
                  <c:v>31.475152969360352</c:v>
                </c:pt>
                <c:pt idx="6">
                  <c:v>30.980823198954262</c:v>
                </c:pt>
                <c:pt idx="7">
                  <c:v>30.98470401763916</c:v>
                </c:pt>
                <c:pt idx="8">
                  <c:v>29.334176381429039</c:v>
                </c:pt>
                <c:pt idx="9">
                  <c:v>74.39282735188803</c:v>
                </c:pt>
                <c:pt idx="10">
                  <c:v>77.144887288411468</c:v>
                </c:pt>
                <c:pt idx="11">
                  <c:v>77.549299875895173</c:v>
                </c:pt>
                <c:pt idx="12">
                  <c:v>76.237775166829437</c:v>
                </c:pt>
                <c:pt idx="13">
                  <c:v>44.020781199137375</c:v>
                </c:pt>
                <c:pt idx="14">
                  <c:v>41.362527211507157</c:v>
                </c:pt>
                <c:pt idx="15">
                  <c:v>39.570935567220047</c:v>
                </c:pt>
                <c:pt idx="16">
                  <c:v>33.027078628540039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F1DD-4F89-978B-6EB4230BE8C1}"/>
            </c:ext>
          </c:extLst>
        </c:ser>
        <c:ser>
          <c:idx val="2"/>
          <c:order val="2"/>
          <c:tx>
            <c:strRef>
              <c:f>OCR!$AF$5</c:f>
              <c:strCache>
                <c:ptCount val="1"/>
                <c:pt idx="0">
                  <c:v>CsA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OCR!$AG$13:$AG$29</c:f>
                <c:numCache>
                  <c:formatCode>General</c:formatCode>
                  <c:ptCount val="17"/>
                  <c:pt idx="0">
                    <c:v>7.0318918228149414</c:v>
                  </c:pt>
                  <c:pt idx="1">
                    <c:v>7.802833080291748</c:v>
                  </c:pt>
                  <c:pt idx="2">
                    <c:v>8.563950777053833</c:v>
                  </c:pt>
                  <c:pt idx="3">
                    <c:v>9.1993660926818848</c:v>
                  </c:pt>
                  <c:pt idx="4">
                    <c:v>9.5089980761210136</c:v>
                  </c:pt>
                  <c:pt idx="5">
                    <c:v>9.2369204362233468</c:v>
                  </c:pt>
                  <c:pt idx="6">
                    <c:v>9.3127974669138602</c:v>
                  </c:pt>
                  <c:pt idx="7">
                    <c:v>9.3932922681172677</c:v>
                  </c:pt>
                  <c:pt idx="8">
                    <c:v>9.1926039854685477</c:v>
                  </c:pt>
                  <c:pt idx="9">
                    <c:v>14.890390078226725</c:v>
                  </c:pt>
                  <c:pt idx="10">
                    <c:v>14.730759302775065</c:v>
                  </c:pt>
                  <c:pt idx="11">
                    <c:v>15.184618473052979</c:v>
                  </c:pt>
                  <c:pt idx="12">
                    <c:v>15.117383162180582</c:v>
                  </c:pt>
                  <c:pt idx="13">
                    <c:v>6.0051420529683437</c:v>
                  </c:pt>
                  <c:pt idx="14">
                    <c:v>5.3038303852081299</c:v>
                  </c:pt>
                  <c:pt idx="15">
                    <c:v>5.0297268231709804</c:v>
                  </c:pt>
                  <c:pt idx="16">
                    <c:v>4.8205877145131435</c:v>
                  </c:pt>
                </c:numCache>
              </c:numRef>
            </c:plus>
            <c:minus>
              <c:numRef>
                <c:f>OCR!$AG$13:$AG$29</c:f>
                <c:numCache>
                  <c:formatCode>General</c:formatCode>
                  <c:ptCount val="17"/>
                  <c:pt idx="0">
                    <c:v>7.0318918228149414</c:v>
                  </c:pt>
                  <c:pt idx="1">
                    <c:v>7.802833080291748</c:v>
                  </c:pt>
                  <c:pt idx="2">
                    <c:v>8.563950777053833</c:v>
                  </c:pt>
                  <c:pt idx="3">
                    <c:v>9.1993660926818848</c:v>
                  </c:pt>
                  <c:pt idx="4">
                    <c:v>9.5089980761210136</c:v>
                  </c:pt>
                  <c:pt idx="5">
                    <c:v>9.2369204362233468</c:v>
                  </c:pt>
                  <c:pt idx="6">
                    <c:v>9.3127974669138602</c:v>
                  </c:pt>
                  <c:pt idx="7">
                    <c:v>9.3932922681172677</c:v>
                  </c:pt>
                  <c:pt idx="8">
                    <c:v>9.1926039854685477</c:v>
                  </c:pt>
                  <c:pt idx="9">
                    <c:v>14.890390078226725</c:v>
                  </c:pt>
                  <c:pt idx="10">
                    <c:v>14.730759302775065</c:v>
                  </c:pt>
                  <c:pt idx="11">
                    <c:v>15.184618473052979</c:v>
                  </c:pt>
                  <c:pt idx="12">
                    <c:v>15.117383162180582</c:v>
                  </c:pt>
                  <c:pt idx="13">
                    <c:v>6.0051420529683437</c:v>
                  </c:pt>
                  <c:pt idx="14">
                    <c:v>5.3038303852081299</c:v>
                  </c:pt>
                  <c:pt idx="15">
                    <c:v>5.0297268231709804</c:v>
                  </c:pt>
                  <c:pt idx="16">
                    <c:v>4.8205877145131435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OCR!$AK$13:$AK$29</c:f>
              <c:numCache>
                <c:formatCode>0</c:formatCode>
                <c:ptCount val="17"/>
                <c:pt idx="0">
                  <c:v>0.33333206176757813</c:v>
                </c:pt>
                <c:pt idx="1">
                  <c:v>6.0833320617675781</c:v>
                </c:pt>
                <c:pt idx="2">
                  <c:v>11.833332061767578</c:v>
                </c:pt>
                <c:pt idx="3">
                  <c:v>17.583332061767578</c:v>
                </c:pt>
                <c:pt idx="4">
                  <c:v>23.333332061767578</c:v>
                </c:pt>
                <c:pt idx="5">
                  <c:v>29.316665649414062</c:v>
                </c:pt>
                <c:pt idx="6">
                  <c:v>35.066665649414063</c:v>
                </c:pt>
                <c:pt idx="7">
                  <c:v>40.833335876464844</c:v>
                </c:pt>
                <c:pt idx="8">
                  <c:v>46.583335876464844</c:v>
                </c:pt>
                <c:pt idx="9">
                  <c:v>52.566665649414063</c:v>
                </c:pt>
                <c:pt idx="10">
                  <c:v>58.316665649414063</c:v>
                </c:pt>
                <c:pt idx="11">
                  <c:v>64.066665649414063</c:v>
                </c:pt>
                <c:pt idx="12">
                  <c:v>69.816665649414063</c:v>
                </c:pt>
                <c:pt idx="13">
                  <c:v>75.816665649414063</c:v>
                </c:pt>
                <c:pt idx="14">
                  <c:v>81.566665649414063</c:v>
                </c:pt>
                <c:pt idx="15">
                  <c:v>87.316665649414063</c:v>
                </c:pt>
                <c:pt idx="16">
                  <c:v>93.066665649414063</c:v>
                </c:pt>
              </c:numCache>
            </c:numRef>
          </c:xVal>
          <c:yVal>
            <c:numRef>
              <c:f>OCR!$AF$13:$AF$29</c:f>
              <c:numCache>
                <c:formatCode>0.000</c:formatCode>
                <c:ptCount val="17"/>
                <c:pt idx="0">
                  <c:v>39.407365798950195</c:v>
                </c:pt>
                <c:pt idx="1">
                  <c:v>45.792595545450851</c:v>
                </c:pt>
                <c:pt idx="2">
                  <c:v>47.805835723876953</c:v>
                </c:pt>
                <c:pt idx="3">
                  <c:v>49.159491221110031</c:v>
                </c:pt>
                <c:pt idx="4">
                  <c:v>47.756735483805343</c:v>
                </c:pt>
                <c:pt idx="5">
                  <c:v>43.251290639241532</c:v>
                </c:pt>
                <c:pt idx="6">
                  <c:v>41.904961903889969</c:v>
                </c:pt>
                <c:pt idx="7">
                  <c:v>42.672922770182296</c:v>
                </c:pt>
                <c:pt idx="8">
                  <c:v>42.025081634521484</c:v>
                </c:pt>
                <c:pt idx="9">
                  <c:v>69.18842061360678</c:v>
                </c:pt>
                <c:pt idx="10">
                  <c:v>69.463391621907562</c:v>
                </c:pt>
                <c:pt idx="11">
                  <c:v>70.93429438273111</c:v>
                </c:pt>
                <c:pt idx="12">
                  <c:v>69.205509185791016</c:v>
                </c:pt>
                <c:pt idx="13">
                  <c:v>38.378566106160477</c:v>
                </c:pt>
                <c:pt idx="14">
                  <c:v>36.583756128946945</c:v>
                </c:pt>
                <c:pt idx="15">
                  <c:v>34.329330444335938</c:v>
                </c:pt>
                <c:pt idx="16">
                  <c:v>27.095799763997398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2-F1DD-4F89-978B-6EB4230BE8C1}"/>
            </c:ext>
          </c:extLst>
        </c:ser>
        <c:ser>
          <c:idx val="3"/>
          <c:order val="3"/>
          <c:tx>
            <c:strRef>
              <c:f>OCR!$AH$5</c:f>
              <c:strCache>
                <c:ptCount val="1"/>
                <c:pt idx="0">
                  <c:v>Thapsigargin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OCR!$AI$13:$AI$29</c:f>
                <c:numCache>
                  <c:formatCode>General</c:formatCode>
                  <c:ptCount val="17"/>
                  <c:pt idx="0">
                    <c:v>9.16747220357259</c:v>
                  </c:pt>
                  <c:pt idx="1">
                    <c:v>9.4232233365376779</c:v>
                  </c:pt>
                  <c:pt idx="2">
                    <c:v>9.5147418975830078</c:v>
                  </c:pt>
                  <c:pt idx="3">
                    <c:v>9.8233421643575021</c:v>
                  </c:pt>
                  <c:pt idx="4">
                    <c:v>9.9228358268737793</c:v>
                  </c:pt>
                  <c:pt idx="5">
                    <c:v>7.4963804880777989</c:v>
                  </c:pt>
                  <c:pt idx="6">
                    <c:v>7.3552543322245274</c:v>
                  </c:pt>
                  <c:pt idx="7">
                    <c:v>7.2003944714864101</c:v>
                  </c:pt>
                  <c:pt idx="8">
                    <c:v>7.3150774637858067</c:v>
                  </c:pt>
                  <c:pt idx="9">
                    <c:v>16.588881015777588</c:v>
                  </c:pt>
                  <c:pt idx="10">
                    <c:v>16.253544648488365</c:v>
                  </c:pt>
                  <c:pt idx="11">
                    <c:v>16.567600727081299</c:v>
                  </c:pt>
                  <c:pt idx="12">
                    <c:v>16.790387312571205</c:v>
                  </c:pt>
                  <c:pt idx="13">
                    <c:v>5.3560235500335693</c:v>
                  </c:pt>
                  <c:pt idx="14">
                    <c:v>5.3120881716410322</c:v>
                  </c:pt>
                  <c:pt idx="15">
                    <c:v>5.0799403190612793</c:v>
                  </c:pt>
                  <c:pt idx="16">
                    <c:v>4.8423678874969482</c:v>
                  </c:pt>
                </c:numCache>
              </c:numRef>
            </c:plus>
            <c:minus>
              <c:numRef>
                <c:f>OCR!$AI$13:$AI$29</c:f>
                <c:numCache>
                  <c:formatCode>General</c:formatCode>
                  <c:ptCount val="17"/>
                  <c:pt idx="0">
                    <c:v>9.16747220357259</c:v>
                  </c:pt>
                  <c:pt idx="1">
                    <c:v>9.4232233365376779</c:v>
                  </c:pt>
                  <c:pt idx="2">
                    <c:v>9.5147418975830078</c:v>
                  </c:pt>
                  <c:pt idx="3">
                    <c:v>9.8233421643575021</c:v>
                  </c:pt>
                  <c:pt idx="4">
                    <c:v>9.9228358268737793</c:v>
                  </c:pt>
                  <c:pt idx="5">
                    <c:v>7.4963804880777989</c:v>
                  </c:pt>
                  <c:pt idx="6">
                    <c:v>7.3552543322245274</c:v>
                  </c:pt>
                  <c:pt idx="7">
                    <c:v>7.2003944714864101</c:v>
                  </c:pt>
                  <c:pt idx="8">
                    <c:v>7.3150774637858067</c:v>
                  </c:pt>
                  <c:pt idx="9">
                    <c:v>16.588881015777588</c:v>
                  </c:pt>
                  <c:pt idx="10">
                    <c:v>16.253544648488365</c:v>
                  </c:pt>
                  <c:pt idx="11">
                    <c:v>16.567600727081299</c:v>
                  </c:pt>
                  <c:pt idx="12">
                    <c:v>16.790387312571205</c:v>
                  </c:pt>
                  <c:pt idx="13">
                    <c:v>5.3560235500335693</c:v>
                  </c:pt>
                  <c:pt idx="14">
                    <c:v>5.3120881716410322</c:v>
                  </c:pt>
                  <c:pt idx="15">
                    <c:v>5.0799403190612793</c:v>
                  </c:pt>
                  <c:pt idx="16">
                    <c:v>4.842367887496948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OCR!$AK$13:$AK$29</c:f>
              <c:numCache>
                <c:formatCode>0</c:formatCode>
                <c:ptCount val="17"/>
                <c:pt idx="0">
                  <c:v>0.33333206176757813</c:v>
                </c:pt>
                <c:pt idx="1">
                  <c:v>6.0833320617675781</c:v>
                </c:pt>
                <c:pt idx="2">
                  <c:v>11.833332061767578</c:v>
                </c:pt>
                <c:pt idx="3">
                  <c:v>17.583332061767578</c:v>
                </c:pt>
                <c:pt idx="4">
                  <c:v>23.333332061767578</c:v>
                </c:pt>
                <c:pt idx="5">
                  <c:v>29.316665649414062</c:v>
                </c:pt>
                <c:pt idx="6">
                  <c:v>35.066665649414063</c:v>
                </c:pt>
                <c:pt idx="7">
                  <c:v>40.833335876464844</c:v>
                </c:pt>
                <c:pt idx="8">
                  <c:v>46.583335876464844</c:v>
                </c:pt>
                <c:pt idx="9">
                  <c:v>52.566665649414063</c:v>
                </c:pt>
                <c:pt idx="10">
                  <c:v>58.316665649414063</c:v>
                </c:pt>
                <c:pt idx="11">
                  <c:v>64.066665649414063</c:v>
                </c:pt>
                <c:pt idx="12">
                  <c:v>69.816665649414063</c:v>
                </c:pt>
                <c:pt idx="13">
                  <c:v>75.816665649414063</c:v>
                </c:pt>
                <c:pt idx="14">
                  <c:v>81.566665649414063</c:v>
                </c:pt>
                <c:pt idx="15">
                  <c:v>87.316665649414063</c:v>
                </c:pt>
                <c:pt idx="16">
                  <c:v>93.066665649414063</c:v>
                </c:pt>
              </c:numCache>
            </c:numRef>
          </c:xVal>
          <c:yVal>
            <c:numRef>
              <c:f>OCR!$AH$13:$AH$29</c:f>
              <c:numCache>
                <c:formatCode>0.000</c:formatCode>
                <c:ptCount val="17"/>
                <c:pt idx="0">
                  <c:v>31.397064208984375</c:v>
                </c:pt>
                <c:pt idx="1">
                  <c:v>35.299694379170731</c:v>
                </c:pt>
                <c:pt idx="2">
                  <c:v>38.202040354410812</c:v>
                </c:pt>
                <c:pt idx="3">
                  <c:v>40.565266927083329</c:v>
                </c:pt>
                <c:pt idx="4">
                  <c:v>39.916529973347977</c:v>
                </c:pt>
                <c:pt idx="5">
                  <c:v>30.389139175415039</c:v>
                </c:pt>
                <c:pt idx="6">
                  <c:v>29.221439361572266</c:v>
                </c:pt>
                <c:pt idx="7">
                  <c:v>29.660557428995769</c:v>
                </c:pt>
                <c:pt idx="8">
                  <c:v>28.110774993896484</c:v>
                </c:pt>
                <c:pt idx="9">
                  <c:v>65.625699996948242</c:v>
                </c:pt>
                <c:pt idx="10">
                  <c:v>66.886437733968108</c:v>
                </c:pt>
                <c:pt idx="11">
                  <c:v>67.553996404012054</c:v>
                </c:pt>
                <c:pt idx="12">
                  <c:v>66.165719985961914</c:v>
                </c:pt>
                <c:pt idx="13">
                  <c:v>21.811886787414551</c:v>
                </c:pt>
                <c:pt idx="14">
                  <c:v>20.973877588907875</c:v>
                </c:pt>
                <c:pt idx="15">
                  <c:v>19.952364921569824</c:v>
                </c:pt>
                <c:pt idx="16">
                  <c:v>13.81718111038208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3-F1DD-4F89-978B-6EB4230BE8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1095168"/>
        <c:axId val="171096704"/>
      </c:scatterChart>
      <c:valAx>
        <c:axId val="171095168"/>
        <c:scaling>
          <c:orientation val="minMax"/>
          <c:min val="0"/>
        </c:scaling>
        <c:delete val="0"/>
        <c:axPos val="b"/>
        <c:numFmt formatCode="0" sourceLinked="1"/>
        <c:majorTickMark val="out"/>
        <c:minorTickMark val="none"/>
        <c:tickLblPos val="nextTo"/>
        <c:spPr>
          <a:ln w="31750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171096704"/>
        <c:crosses val="autoZero"/>
        <c:crossBetween val="midCat"/>
      </c:valAx>
      <c:valAx>
        <c:axId val="171096704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0" sourceLinked="0"/>
        <c:majorTickMark val="out"/>
        <c:minorTickMark val="none"/>
        <c:tickLblPos val="nextTo"/>
        <c:spPr>
          <a:ln w="31750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171095168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9789</cdr:x>
      <cdr:y>0.06915</cdr:y>
    </cdr:from>
    <cdr:to>
      <cdr:x>0.49789</cdr:x>
      <cdr:y>0.16895</cdr:y>
    </cdr:to>
    <cdr:cxnSp macro="">
      <cdr:nvCxnSpPr>
        <cdr:cNvPr id="2" name="Egyenes összekötő nyíllal 1"/>
        <cdr:cNvCxnSpPr/>
      </cdr:nvCxnSpPr>
      <cdr:spPr>
        <a:xfrm xmlns:a="http://schemas.openxmlformats.org/drawingml/2006/main">
          <a:off x="2276353" y="199572"/>
          <a:ext cx="0" cy="288030"/>
        </a:xfrm>
        <a:prstGeom xmlns:a="http://schemas.openxmlformats.org/drawingml/2006/main" prst="straightConnector1">
          <a:avLst/>
        </a:prstGeom>
        <a:ln xmlns:a="http://schemas.openxmlformats.org/drawingml/2006/main" w="19050">
          <a:solidFill>
            <a:schemeClr val="tx1"/>
          </a:solidFill>
          <a:tailEnd type="arrow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73414</cdr:x>
      <cdr:y>0.06915</cdr:y>
    </cdr:from>
    <cdr:to>
      <cdr:x>0.73414</cdr:x>
      <cdr:y>0.16895</cdr:y>
    </cdr:to>
    <cdr:cxnSp macro="">
      <cdr:nvCxnSpPr>
        <cdr:cNvPr id="3" name="Egyenes összekötő nyíllal 2"/>
        <cdr:cNvCxnSpPr/>
      </cdr:nvCxnSpPr>
      <cdr:spPr>
        <a:xfrm xmlns:a="http://schemas.openxmlformats.org/drawingml/2006/main">
          <a:off x="3356488" y="210067"/>
          <a:ext cx="0" cy="303177"/>
        </a:xfrm>
        <a:prstGeom xmlns:a="http://schemas.openxmlformats.org/drawingml/2006/main" prst="straightConnector1">
          <a:avLst/>
        </a:prstGeom>
        <a:ln xmlns:a="http://schemas.openxmlformats.org/drawingml/2006/main" w="19050">
          <a:solidFill>
            <a:schemeClr val="tx1"/>
          </a:solidFill>
          <a:tailEnd type="arrow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hu-HU" smtClean="0"/>
              <a:t>Mintacím szerkesztése</a:t>
            </a:r>
            <a:endParaRPr lang="en-US"/>
          </a:p>
        </p:txBody>
      </p:sp>
      <p:sp>
        <p:nvSpPr>
          <p:cNvPr id="3" name="Alcím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hu-HU" smtClean="0"/>
              <a:t>Alcím mintájának szerkesztése</a:t>
            </a:r>
            <a:endParaRPr lang="en-US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9ADFC-E28E-4CAE-A5E8-0B06C4F2F9D4}" type="datetimeFigureOut">
              <a:rPr lang="en-US" smtClean="0"/>
              <a:t>2/4/2020</a:t>
            </a:fld>
            <a:endParaRPr lang="en-US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45F52-835A-4726-B0A5-3EE1B9F05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93210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/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9ADFC-E28E-4CAE-A5E8-0B06C4F2F9D4}" type="datetimeFigureOut">
              <a:rPr lang="en-US" smtClean="0"/>
              <a:t>2/4/2020</a:t>
            </a:fld>
            <a:endParaRPr lang="en-US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45F52-835A-4726-B0A5-3EE1B9F05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7902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hu-HU" smtClean="0"/>
              <a:t>Mintacím szerkesztése</a:t>
            </a:r>
            <a:endParaRPr lang="en-US"/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9ADFC-E28E-4CAE-A5E8-0B06C4F2F9D4}" type="datetimeFigureOut">
              <a:rPr lang="en-US" smtClean="0"/>
              <a:t>2/4/2020</a:t>
            </a:fld>
            <a:endParaRPr lang="en-US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45F52-835A-4726-B0A5-3EE1B9F05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07189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/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9ADFC-E28E-4CAE-A5E8-0B06C4F2F9D4}" type="datetimeFigureOut">
              <a:rPr lang="en-US" smtClean="0"/>
              <a:t>2/4/2020</a:t>
            </a:fld>
            <a:endParaRPr lang="en-US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45F52-835A-4726-B0A5-3EE1B9F05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17718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hu-HU" smtClean="0"/>
              <a:t>Mintacím szerkesztése</a:t>
            </a:r>
            <a:endParaRPr lang="en-US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9ADFC-E28E-4CAE-A5E8-0B06C4F2F9D4}" type="datetimeFigureOut">
              <a:rPr lang="en-US" smtClean="0"/>
              <a:t>2/4/2020</a:t>
            </a:fld>
            <a:endParaRPr lang="en-US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45F52-835A-4726-B0A5-3EE1B9F05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0908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/>
          </a:p>
        </p:txBody>
      </p:sp>
      <p:sp>
        <p:nvSpPr>
          <p:cNvPr id="3" name="Tartalom helye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/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/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9ADFC-E28E-4CAE-A5E8-0B06C4F2F9D4}" type="datetimeFigureOut">
              <a:rPr lang="en-US" smtClean="0"/>
              <a:t>2/4/2020</a:t>
            </a:fld>
            <a:endParaRPr lang="en-US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45F52-835A-4726-B0A5-3EE1B9F05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1724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hu-HU" smtClean="0"/>
              <a:t>Mintacím szerkesztése</a:t>
            </a:r>
            <a:endParaRPr lang="en-US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/>
          </a:p>
        </p:txBody>
      </p:sp>
      <p:sp>
        <p:nvSpPr>
          <p:cNvPr id="5" name="Szöveg hely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6" name="Tartalom helye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/>
          </a:p>
        </p:txBody>
      </p:sp>
      <p:sp>
        <p:nvSpPr>
          <p:cNvPr id="7" name="Dátum hely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9ADFC-E28E-4CAE-A5E8-0B06C4F2F9D4}" type="datetimeFigureOut">
              <a:rPr lang="en-US" smtClean="0"/>
              <a:t>2/4/2020</a:t>
            </a:fld>
            <a:endParaRPr lang="en-US"/>
          </a:p>
        </p:txBody>
      </p:sp>
      <p:sp>
        <p:nvSpPr>
          <p:cNvPr id="8" name="Élőláb hely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Dia számának hely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45F52-835A-4726-B0A5-3EE1B9F05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02729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/>
          </a:p>
        </p:txBody>
      </p:sp>
      <p:sp>
        <p:nvSpPr>
          <p:cNvPr id="3" name="Dátum hely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9ADFC-E28E-4CAE-A5E8-0B06C4F2F9D4}" type="datetimeFigureOut">
              <a:rPr lang="en-US" smtClean="0"/>
              <a:t>2/4/2020</a:t>
            </a:fld>
            <a:endParaRPr lang="en-US"/>
          </a:p>
        </p:txBody>
      </p:sp>
      <p:sp>
        <p:nvSpPr>
          <p:cNvPr id="4" name="Élőláb hely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Dia számának hely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45F52-835A-4726-B0A5-3EE1B9F05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87990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9ADFC-E28E-4CAE-A5E8-0B06C4F2F9D4}" type="datetimeFigureOut">
              <a:rPr lang="en-US" smtClean="0"/>
              <a:t>2/4/2020</a:t>
            </a:fld>
            <a:endParaRPr lang="en-US"/>
          </a:p>
        </p:txBody>
      </p:sp>
      <p:sp>
        <p:nvSpPr>
          <p:cNvPr id="3" name="Élőláb hely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45F52-835A-4726-B0A5-3EE1B9F05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46814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hu-HU" smtClean="0"/>
              <a:t>Mintacím szerkesztése</a:t>
            </a:r>
            <a:endParaRPr lang="en-US"/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9ADFC-E28E-4CAE-A5E8-0B06C4F2F9D4}" type="datetimeFigureOut">
              <a:rPr lang="en-US" smtClean="0"/>
              <a:t>2/4/2020</a:t>
            </a:fld>
            <a:endParaRPr lang="en-US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45F52-835A-4726-B0A5-3EE1B9F05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39614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hu-HU" smtClean="0"/>
              <a:t>Mintacím szerkesztése</a:t>
            </a:r>
            <a:endParaRPr lang="en-US"/>
          </a:p>
        </p:txBody>
      </p:sp>
      <p:sp>
        <p:nvSpPr>
          <p:cNvPr id="3" name="Kép hely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9ADFC-E28E-4CAE-A5E8-0B06C4F2F9D4}" type="datetimeFigureOut">
              <a:rPr lang="en-US" smtClean="0"/>
              <a:t>2/4/2020</a:t>
            </a:fld>
            <a:endParaRPr lang="en-US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45F52-835A-4726-B0A5-3EE1B9F05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44328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 smtClean="0"/>
              <a:t>Mintacím szerkesztése</a:t>
            </a:r>
            <a:endParaRPr lang="en-US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/>
          </a:p>
        </p:txBody>
      </p:sp>
      <p:sp>
        <p:nvSpPr>
          <p:cNvPr id="4" name="Dátum hely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89ADFC-E28E-4CAE-A5E8-0B06C4F2F9D4}" type="datetimeFigureOut">
              <a:rPr lang="en-US" smtClean="0"/>
              <a:t>2/4/2020</a:t>
            </a:fld>
            <a:endParaRPr lang="en-US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945F52-835A-4726-B0A5-3EE1B9F05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86756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8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36237342"/>
              </p:ext>
            </p:extLst>
          </p:nvPr>
        </p:nvGraphicFramePr>
        <p:xfrm>
          <a:off x="768052" y="1193216"/>
          <a:ext cx="3503269" cy="23367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7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74424465"/>
              </p:ext>
            </p:extLst>
          </p:nvPr>
        </p:nvGraphicFramePr>
        <p:xfrm>
          <a:off x="4717654" y="1144952"/>
          <a:ext cx="3328367" cy="23766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extBox 33"/>
          <p:cNvSpPr txBox="1"/>
          <p:nvPr/>
        </p:nvSpPr>
        <p:spPr>
          <a:xfrm>
            <a:off x="232244" y="237962"/>
            <a:ext cx="11134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b="1" dirty="0" err="1" smtClean="0"/>
              <a:t>Figure</a:t>
            </a:r>
            <a:r>
              <a:rPr lang="hu-HU" b="1" dirty="0" smtClean="0"/>
              <a:t> S</a:t>
            </a:r>
            <a:r>
              <a:rPr lang="en-US" b="1" dirty="0" smtClean="0"/>
              <a:t>1</a:t>
            </a:r>
            <a:r>
              <a:rPr lang="en-US" b="1" dirty="0" smtClean="0"/>
              <a:t>.</a:t>
            </a:r>
            <a:endParaRPr lang="en-US" b="1" dirty="0"/>
          </a:p>
        </p:txBody>
      </p:sp>
      <p:sp>
        <p:nvSpPr>
          <p:cNvPr id="3" name="Textfeld 2"/>
          <p:cNvSpPr txBox="1"/>
          <p:nvPr/>
        </p:nvSpPr>
        <p:spPr>
          <a:xfrm>
            <a:off x="478974" y="902043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4" name="Textfeld 3"/>
          <p:cNvSpPr txBox="1"/>
          <p:nvPr/>
        </p:nvSpPr>
        <p:spPr>
          <a:xfrm>
            <a:off x="4403144" y="902043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5" name="Textfeld 4"/>
          <p:cNvSpPr txBox="1"/>
          <p:nvPr/>
        </p:nvSpPr>
        <p:spPr>
          <a:xfrm>
            <a:off x="454883" y="3012603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C</a:t>
            </a:r>
            <a:endParaRPr lang="en-US" b="1" dirty="0"/>
          </a:p>
        </p:txBody>
      </p:sp>
      <p:grpSp>
        <p:nvGrpSpPr>
          <p:cNvPr id="14" name="Csoportba foglalás 12"/>
          <p:cNvGrpSpPr/>
          <p:nvPr/>
        </p:nvGrpSpPr>
        <p:grpSpPr>
          <a:xfrm>
            <a:off x="4281895" y="2952953"/>
            <a:ext cx="4243341" cy="3668886"/>
            <a:chOff x="3637155" y="2118856"/>
            <a:chExt cx="5178118" cy="4381484"/>
          </a:xfrm>
        </p:grpSpPr>
        <p:graphicFrame>
          <p:nvGraphicFramePr>
            <p:cNvPr id="15" name="Diagram 1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28762594"/>
                </p:ext>
              </p:extLst>
            </p:nvPr>
          </p:nvGraphicFramePr>
          <p:xfrm>
            <a:off x="3936985" y="2410623"/>
            <a:ext cx="4878288" cy="408971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6" name="Szövegdoboz 14"/>
            <p:cNvSpPr txBox="1"/>
            <p:nvPr/>
          </p:nvSpPr>
          <p:spPr>
            <a:xfrm rot="16200000">
              <a:off x="2008986" y="3747025"/>
              <a:ext cx="3594358" cy="3380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u-HU" sz="1200" b="1" dirty="0" smtClean="0"/>
                <a:t>OCR </a:t>
              </a:r>
              <a:r>
                <a:rPr lang="hu-HU" sz="1200" b="1" dirty="0" err="1" smtClean="0"/>
                <a:t>pmol</a:t>
              </a:r>
              <a:r>
                <a:rPr lang="hu-HU" sz="1200" b="1" dirty="0" smtClean="0"/>
                <a:t>/min/ 2*10</a:t>
              </a:r>
              <a:r>
                <a:rPr lang="hu-HU" sz="1200" b="1" baseline="30000" dirty="0"/>
                <a:t>4</a:t>
              </a:r>
              <a:r>
                <a:rPr lang="hu-HU" sz="1200" b="1" dirty="0" smtClean="0"/>
                <a:t> </a:t>
              </a:r>
              <a:r>
                <a:rPr lang="hu-HU" sz="1200" b="1" dirty="0" err="1" smtClean="0"/>
                <a:t>cell</a:t>
              </a:r>
              <a:endParaRPr lang="en-US" sz="1200" b="1" dirty="0"/>
            </a:p>
          </p:txBody>
        </p:sp>
      </p:grpSp>
      <p:grpSp>
        <p:nvGrpSpPr>
          <p:cNvPr id="6" name="Csoportba foglalás 4"/>
          <p:cNvGrpSpPr/>
          <p:nvPr/>
        </p:nvGrpSpPr>
        <p:grpSpPr>
          <a:xfrm>
            <a:off x="478974" y="3354232"/>
            <a:ext cx="3470616" cy="2679557"/>
            <a:chOff x="-8679" y="44623"/>
            <a:chExt cx="4860085" cy="3603372"/>
          </a:xfrm>
        </p:grpSpPr>
        <p:sp>
          <p:nvSpPr>
            <p:cNvPr id="7" name="Szövegdoboz 5"/>
            <p:cNvSpPr txBox="1"/>
            <p:nvPr/>
          </p:nvSpPr>
          <p:spPr>
            <a:xfrm rot="16200000">
              <a:off x="-1611909" y="1647853"/>
              <a:ext cx="3594356" cy="3878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u-HU" sz="1200" b="1" dirty="0" smtClean="0"/>
                <a:t>OCR </a:t>
              </a:r>
              <a:r>
                <a:rPr lang="hu-HU" sz="1200" b="1" dirty="0" err="1" smtClean="0"/>
                <a:t>pmol</a:t>
              </a:r>
              <a:r>
                <a:rPr lang="hu-HU" sz="1200" b="1" dirty="0" smtClean="0"/>
                <a:t>/min/ 2*10</a:t>
              </a:r>
              <a:r>
                <a:rPr lang="hu-HU" sz="1200" b="1" baseline="30000" dirty="0"/>
                <a:t>4</a:t>
              </a:r>
              <a:r>
                <a:rPr lang="hu-HU" sz="1200" b="1" dirty="0" smtClean="0"/>
                <a:t> </a:t>
              </a:r>
              <a:r>
                <a:rPr lang="hu-HU" sz="1200" b="1" dirty="0" err="1" smtClean="0"/>
                <a:t>cell</a:t>
              </a:r>
              <a:endParaRPr lang="en-US" sz="1200" b="1" dirty="0"/>
            </a:p>
          </p:txBody>
        </p:sp>
        <p:sp>
          <p:nvSpPr>
            <p:cNvPr id="8" name="Szövegdoboz 6"/>
            <p:cNvSpPr txBox="1"/>
            <p:nvPr/>
          </p:nvSpPr>
          <p:spPr>
            <a:xfrm>
              <a:off x="1331640" y="3275497"/>
              <a:ext cx="2304256" cy="372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u-HU" sz="1200" b="1" dirty="0" smtClean="0"/>
                <a:t>Time (min)</a:t>
              </a:r>
              <a:endParaRPr lang="en-US" sz="1200" b="1" dirty="0"/>
            </a:p>
          </p:txBody>
        </p:sp>
        <p:graphicFrame>
          <p:nvGraphicFramePr>
            <p:cNvPr id="9" name="Diagram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468745611"/>
                </p:ext>
              </p:extLst>
            </p:nvPr>
          </p:nvGraphicFramePr>
          <p:xfrm>
            <a:off x="279406" y="565132"/>
            <a:ext cx="4572000" cy="288607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cxnSp>
          <p:nvCxnSpPr>
            <p:cNvPr id="10" name="Egyenes összekötő nyíllal 8"/>
            <p:cNvCxnSpPr/>
            <p:nvPr/>
          </p:nvCxnSpPr>
          <p:spPr>
            <a:xfrm>
              <a:off x="1691680" y="1340768"/>
              <a:ext cx="0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Szövegdoboz 9"/>
            <p:cNvSpPr txBox="1"/>
            <p:nvPr/>
          </p:nvSpPr>
          <p:spPr>
            <a:xfrm>
              <a:off x="1043608" y="1094547"/>
              <a:ext cx="12961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u-HU" sz="1000" b="1" dirty="0" err="1"/>
                <a:t>O</a:t>
              </a:r>
              <a:r>
                <a:rPr lang="hu-HU" sz="1000" b="1" dirty="0" err="1" smtClean="0"/>
                <a:t>ligomycin</a:t>
              </a:r>
              <a:endParaRPr lang="en-US" sz="1000" b="1" dirty="0"/>
            </a:p>
          </p:txBody>
        </p:sp>
        <p:sp>
          <p:nvSpPr>
            <p:cNvPr id="12" name="Szövegdoboz 10"/>
            <p:cNvSpPr txBox="1"/>
            <p:nvPr/>
          </p:nvSpPr>
          <p:spPr>
            <a:xfrm>
              <a:off x="1907704" y="493639"/>
              <a:ext cx="12961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u-HU" sz="1000" b="1" dirty="0" smtClean="0"/>
                <a:t>FCCP</a:t>
              </a:r>
              <a:endParaRPr lang="en-US" sz="1000" b="1" dirty="0"/>
            </a:p>
          </p:txBody>
        </p:sp>
        <p:sp>
          <p:nvSpPr>
            <p:cNvPr id="13" name="Szövegdoboz 11"/>
            <p:cNvSpPr txBox="1"/>
            <p:nvPr/>
          </p:nvSpPr>
          <p:spPr>
            <a:xfrm>
              <a:off x="2880948" y="493639"/>
              <a:ext cx="1572090" cy="2897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u-HU" sz="800" b="1" dirty="0" smtClean="0"/>
                <a:t>Rotenon</a:t>
              </a:r>
              <a:r>
                <a:rPr lang="de-CH" sz="800" b="1" dirty="0" smtClean="0"/>
                <a:t>e</a:t>
              </a:r>
              <a:r>
                <a:rPr lang="hu-HU" sz="800" b="1" dirty="0" smtClean="0"/>
                <a:t>+Antimycin</a:t>
              </a:r>
              <a:endParaRPr lang="en-US" sz="800" b="1" dirty="0"/>
            </a:p>
          </p:txBody>
        </p:sp>
      </p:grpSp>
      <p:sp>
        <p:nvSpPr>
          <p:cNvPr id="19" name="Szövegdoboz 18"/>
          <p:cNvSpPr txBox="1"/>
          <p:nvPr/>
        </p:nvSpPr>
        <p:spPr>
          <a:xfrm>
            <a:off x="1443525" y="902043"/>
            <a:ext cx="21523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Mitochondrial superoxide</a:t>
            </a:r>
            <a:endParaRPr lang="en-US" sz="1200" b="1" dirty="0"/>
          </a:p>
        </p:txBody>
      </p:sp>
      <p:sp>
        <p:nvSpPr>
          <p:cNvPr id="20" name="Szövegdoboz 19"/>
          <p:cNvSpPr txBox="1"/>
          <p:nvPr/>
        </p:nvSpPr>
        <p:spPr>
          <a:xfrm>
            <a:off x="4991702" y="902043"/>
            <a:ext cx="27802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Mitochondrial membrane potential</a:t>
            </a:r>
            <a:endParaRPr lang="en-US" sz="1200" b="1" dirty="0"/>
          </a:p>
        </p:txBody>
      </p:sp>
      <p:sp>
        <p:nvSpPr>
          <p:cNvPr id="21" name="Szövegdoboz 20"/>
          <p:cNvSpPr txBox="1"/>
          <p:nvPr/>
        </p:nvSpPr>
        <p:spPr>
          <a:xfrm rot="16200000">
            <a:off x="3916483" y="1670596"/>
            <a:ext cx="15371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% of control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8645927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6</Words>
  <Application>Microsoft Office PowerPoint</Application>
  <PresentationFormat>Diavetítés a képernyőre (4:3 oldalarány)</PresentationFormat>
  <Paragraphs>14</Paragraphs>
  <Slides>1</Slides>
  <Notes>0</Notes>
  <HiddenSlides>0</HiddenSlides>
  <MMClips>0</MMClips>
  <ScaleCrop>false</ScaleCrop>
  <HeadingPairs>
    <vt:vector size="4" baseType="variant"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2" baseType="lpstr">
      <vt:lpstr>Office-téma</vt:lpstr>
      <vt:lpstr>PowerPoint bemutat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bemutató</dc:title>
  <dc:creator>user</dc:creator>
  <cp:lastModifiedBy>user</cp:lastModifiedBy>
  <cp:revision>1</cp:revision>
  <dcterms:created xsi:type="dcterms:W3CDTF">2020-02-04T13:10:35Z</dcterms:created>
  <dcterms:modified xsi:type="dcterms:W3CDTF">2020-02-04T13:11:25Z</dcterms:modified>
</cp:coreProperties>
</file>